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ep%20C%20Ontario%20Prevale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onthly rate of HCV-specific hospitalizations with HCC per 1,000,000 of HCV patient population in Ontario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4"/>
          <c:order val="0"/>
          <c:tx>
            <c:strRef>
              <c:f>Graphs!$F$1</c:f>
              <c:strCache>
                <c:ptCount val="1"/>
                <c:pt idx="0">
                  <c:v>Rate of HCC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Graphs!$A$2:$A$169</c:f>
              <c:numCache>
                <c:formatCode>[$-409]mmmm\ d\,\ yyyy;@</c:formatCode>
                <c:ptCount val="168"/>
                <c:pt idx="0">
                  <c:v>38808</c:v>
                </c:pt>
                <c:pt idx="1">
                  <c:v>38838</c:v>
                </c:pt>
                <c:pt idx="2">
                  <c:v>38869</c:v>
                </c:pt>
                <c:pt idx="3">
                  <c:v>38899</c:v>
                </c:pt>
                <c:pt idx="4">
                  <c:v>38930</c:v>
                </c:pt>
                <c:pt idx="5">
                  <c:v>38961</c:v>
                </c:pt>
                <c:pt idx="6">
                  <c:v>38991</c:v>
                </c:pt>
                <c:pt idx="7">
                  <c:v>39022</c:v>
                </c:pt>
                <c:pt idx="8">
                  <c:v>39052</c:v>
                </c:pt>
                <c:pt idx="9">
                  <c:v>39083</c:v>
                </c:pt>
                <c:pt idx="10">
                  <c:v>39114</c:v>
                </c:pt>
                <c:pt idx="11">
                  <c:v>39142</c:v>
                </c:pt>
                <c:pt idx="12">
                  <c:v>39173</c:v>
                </c:pt>
                <c:pt idx="13">
                  <c:v>39203</c:v>
                </c:pt>
                <c:pt idx="14">
                  <c:v>39234</c:v>
                </c:pt>
                <c:pt idx="15">
                  <c:v>39264</c:v>
                </c:pt>
                <c:pt idx="16">
                  <c:v>39295</c:v>
                </c:pt>
                <c:pt idx="17">
                  <c:v>39326</c:v>
                </c:pt>
                <c:pt idx="18">
                  <c:v>39356</c:v>
                </c:pt>
                <c:pt idx="19">
                  <c:v>39387</c:v>
                </c:pt>
                <c:pt idx="20">
                  <c:v>39417</c:v>
                </c:pt>
                <c:pt idx="21">
                  <c:v>39448</c:v>
                </c:pt>
                <c:pt idx="22">
                  <c:v>39479</c:v>
                </c:pt>
                <c:pt idx="23">
                  <c:v>39508</c:v>
                </c:pt>
                <c:pt idx="24">
                  <c:v>39539</c:v>
                </c:pt>
                <c:pt idx="25">
                  <c:v>39569</c:v>
                </c:pt>
                <c:pt idx="26">
                  <c:v>39600</c:v>
                </c:pt>
                <c:pt idx="27">
                  <c:v>39630</c:v>
                </c:pt>
                <c:pt idx="28">
                  <c:v>39661</c:v>
                </c:pt>
                <c:pt idx="29">
                  <c:v>39692</c:v>
                </c:pt>
                <c:pt idx="30">
                  <c:v>39722</c:v>
                </c:pt>
                <c:pt idx="31">
                  <c:v>39753</c:v>
                </c:pt>
                <c:pt idx="32">
                  <c:v>39783</c:v>
                </c:pt>
                <c:pt idx="33">
                  <c:v>39814</c:v>
                </c:pt>
                <c:pt idx="34">
                  <c:v>39845</c:v>
                </c:pt>
                <c:pt idx="35">
                  <c:v>39873</c:v>
                </c:pt>
                <c:pt idx="36">
                  <c:v>39904</c:v>
                </c:pt>
                <c:pt idx="37">
                  <c:v>39934</c:v>
                </c:pt>
                <c:pt idx="38">
                  <c:v>39965</c:v>
                </c:pt>
                <c:pt idx="39">
                  <c:v>39995</c:v>
                </c:pt>
                <c:pt idx="40">
                  <c:v>40026</c:v>
                </c:pt>
                <c:pt idx="41">
                  <c:v>40057</c:v>
                </c:pt>
                <c:pt idx="42">
                  <c:v>40087</c:v>
                </c:pt>
                <c:pt idx="43">
                  <c:v>40118</c:v>
                </c:pt>
                <c:pt idx="44">
                  <c:v>40148</c:v>
                </c:pt>
                <c:pt idx="45">
                  <c:v>40179</c:v>
                </c:pt>
                <c:pt idx="46">
                  <c:v>40210</c:v>
                </c:pt>
                <c:pt idx="47">
                  <c:v>40238</c:v>
                </c:pt>
                <c:pt idx="48">
                  <c:v>40269</c:v>
                </c:pt>
                <c:pt idx="49">
                  <c:v>40299</c:v>
                </c:pt>
                <c:pt idx="50">
                  <c:v>40330</c:v>
                </c:pt>
                <c:pt idx="51">
                  <c:v>40360</c:v>
                </c:pt>
                <c:pt idx="52">
                  <c:v>40391</c:v>
                </c:pt>
                <c:pt idx="53">
                  <c:v>40422</c:v>
                </c:pt>
                <c:pt idx="54">
                  <c:v>40452</c:v>
                </c:pt>
                <c:pt idx="55">
                  <c:v>40483</c:v>
                </c:pt>
                <c:pt idx="56">
                  <c:v>40513</c:v>
                </c:pt>
                <c:pt idx="57">
                  <c:v>40544</c:v>
                </c:pt>
                <c:pt idx="58">
                  <c:v>40575</c:v>
                </c:pt>
                <c:pt idx="59">
                  <c:v>40603</c:v>
                </c:pt>
                <c:pt idx="60">
                  <c:v>40634</c:v>
                </c:pt>
                <c:pt idx="61">
                  <c:v>40664</c:v>
                </c:pt>
                <c:pt idx="62">
                  <c:v>40695</c:v>
                </c:pt>
                <c:pt idx="63">
                  <c:v>40725</c:v>
                </c:pt>
                <c:pt idx="64">
                  <c:v>40756</c:v>
                </c:pt>
                <c:pt idx="65">
                  <c:v>40787</c:v>
                </c:pt>
                <c:pt idx="66">
                  <c:v>40817</c:v>
                </c:pt>
                <c:pt idx="67">
                  <c:v>40848</c:v>
                </c:pt>
                <c:pt idx="68">
                  <c:v>40878</c:v>
                </c:pt>
                <c:pt idx="69">
                  <c:v>40909</c:v>
                </c:pt>
                <c:pt idx="70">
                  <c:v>40940</c:v>
                </c:pt>
                <c:pt idx="71">
                  <c:v>40969</c:v>
                </c:pt>
                <c:pt idx="72">
                  <c:v>41000</c:v>
                </c:pt>
                <c:pt idx="73">
                  <c:v>41030</c:v>
                </c:pt>
                <c:pt idx="74">
                  <c:v>41061</c:v>
                </c:pt>
                <c:pt idx="75">
                  <c:v>41091</c:v>
                </c:pt>
                <c:pt idx="76">
                  <c:v>41122</c:v>
                </c:pt>
                <c:pt idx="77">
                  <c:v>41153</c:v>
                </c:pt>
                <c:pt idx="78">
                  <c:v>41183</c:v>
                </c:pt>
                <c:pt idx="79">
                  <c:v>41214</c:v>
                </c:pt>
                <c:pt idx="80">
                  <c:v>41244</c:v>
                </c:pt>
                <c:pt idx="81">
                  <c:v>41275</c:v>
                </c:pt>
                <c:pt idx="82">
                  <c:v>41306</c:v>
                </c:pt>
                <c:pt idx="83">
                  <c:v>41334</c:v>
                </c:pt>
                <c:pt idx="84">
                  <c:v>41365</c:v>
                </c:pt>
                <c:pt idx="85">
                  <c:v>41395</c:v>
                </c:pt>
                <c:pt idx="86">
                  <c:v>41426</c:v>
                </c:pt>
                <c:pt idx="87">
                  <c:v>41456</c:v>
                </c:pt>
                <c:pt idx="88">
                  <c:v>41487</c:v>
                </c:pt>
                <c:pt idx="89">
                  <c:v>41518</c:v>
                </c:pt>
                <c:pt idx="90">
                  <c:v>41548</c:v>
                </c:pt>
                <c:pt idx="91">
                  <c:v>41579</c:v>
                </c:pt>
                <c:pt idx="92">
                  <c:v>41609</c:v>
                </c:pt>
                <c:pt idx="93">
                  <c:v>41640</c:v>
                </c:pt>
                <c:pt idx="94">
                  <c:v>41671</c:v>
                </c:pt>
                <c:pt idx="95">
                  <c:v>41699</c:v>
                </c:pt>
                <c:pt idx="96">
                  <c:v>41730</c:v>
                </c:pt>
                <c:pt idx="97">
                  <c:v>41760</c:v>
                </c:pt>
                <c:pt idx="98">
                  <c:v>41791</c:v>
                </c:pt>
                <c:pt idx="99">
                  <c:v>41821</c:v>
                </c:pt>
                <c:pt idx="100">
                  <c:v>41852</c:v>
                </c:pt>
                <c:pt idx="101">
                  <c:v>41883</c:v>
                </c:pt>
                <c:pt idx="102">
                  <c:v>41913</c:v>
                </c:pt>
                <c:pt idx="103">
                  <c:v>41944</c:v>
                </c:pt>
                <c:pt idx="104">
                  <c:v>41974</c:v>
                </c:pt>
                <c:pt idx="105">
                  <c:v>42005</c:v>
                </c:pt>
                <c:pt idx="106">
                  <c:v>42036</c:v>
                </c:pt>
                <c:pt idx="107">
                  <c:v>42064</c:v>
                </c:pt>
                <c:pt idx="108">
                  <c:v>42095</c:v>
                </c:pt>
                <c:pt idx="109">
                  <c:v>42125</c:v>
                </c:pt>
                <c:pt idx="110">
                  <c:v>42156</c:v>
                </c:pt>
                <c:pt idx="111">
                  <c:v>42186</c:v>
                </c:pt>
                <c:pt idx="112">
                  <c:v>42217</c:v>
                </c:pt>
                <c:pt idx="113">
                  <c:v>42248</c:v>
                </c:pt>
                <c:pt idx="114">
                  <c:v>42278</c:v>
                </c:pt>
                <c:pt idx="115">
                  <c:v>42309</c:v>
                </c:pt>
                <c:pt idx="116">
                  <c:v>42339</c:v>
                </c:pt>
                <c:pt idx="117">
                  <c:v>42370</c:v>
                </c:pt>
                <c:pt idx="118">
                  <c:v>42401</c:v>
                </c:pt>
                <c:pt idx="119">
                  <c:v>42430</c:v>
                </c:pt>
                <c:pt idx="120">
                  <c:v>42461</c:v>
                </c:pt>
                <c:pt idx="121">
                  <c:v>42491</c:v>
                </c:pt>
                <c:pt idx="122">
                  <c:v>42522</c:v>
                </c:pt>
                <c:pt idx="123">
                  <c:v>42552</c:v>
                </c:pt>
                <c:pt idx="124">
                  <c:v>42583</c:v>
                </c:pt>
                <c:pt idx="125">
                  <c:v>42614</c:v>
                </c:pt>
                <c:pt idx="126">
                  <c:v>42644</c:v>
                </c:pt>
                <c:pt idx="127">
                  <c:v>42675</c:v>
                </c:pt>
                <c:pt idx="128">
                  <c:v>42705</c:v>
                </c:pt>
                <c:pt idx="129">
                  <c:v>42736</c:v>
                </c:pt>
                <c:pt idx="130">
                  <c:v>42767</c:v>
                </c:pt>
                <c:pt idx="131">
                  <c:v>42795</c:v>
                </c:pt>
                <c:pt idx="132">
                  <c:v>42826</c:v>
                </c:pt>
                <c:pt idx="133">
                  <c:v>42856</c:v>
                </c:pt>
                <c:pt idx="134">
                  <c:v>42887</c:v>
                </c:pt>
                <c:pt idx="135">
                  <c:v>42917</c:v>
                </c:pt>
                <c:pt idx="136">
                  <c:v>42948</c:v>
                </c:pt>
                <c:pt idx="137">
                  <c:v>42979</c:v>
                </c:pt>
                <c:pt idx="138">
                  <c:v>43009</c:v>
                </c:pt>
                <c:pt idx="139">
                  <c:v>43040</c:v>
                </c:pt>
                <c:pt idx="140">
                  <c:v>43070</c:v>
                </c:pt>
                <c:pt idx="141">
                  <c:v>43101</c:v>
                </c:pt>
                <c:pt idx="142">
                  <c:v>43132</c:v>
                </c:pt>
                <c:pt idx="143">
                  <c:v>43160</c:v>
                </c:pt>
                <c:pt idx="144">
                  <c:v>43191</c:v>
                </c:pt>
                <c:pt idx="145">
                  <c:v>43221</c:v>
                </c:pt>
                <c:pt idx="146">
                  <c:v>43252</c:v>
                </c:pt>
                <c:pt idx="147">
                  <c:v>43282</c:v>
                </c:pt>
                <c:pt idx="148">
                  <c:v>43313</c:v>
                </c:pt>
                <c:pt idx="149">
                  <c:v>43344</c:v>
                </c:pt>
                <c:pt idx="150">
                  <c:v>43374</c:v>
                </c:pt>
                <c:pt idx="151">
                  <c:v>43405</c:v>
                </c:pt>
                <c:pt idx="152">
                  <c:v>43435</c:v>
                </c:pt>
                <c:pt idx="153">
                  <c:v>43466</c:v>
                </c:pt>
                <c:pt idx="154">
                  <c:v>43497</c:v>
                </c:pt>
                <c:pt idx="155">
                  <c:v>43525</c:v>
                </c:pt>
                <c:pt idx="156">
                  <c:v>43556</c:v>
                </c:pt>
                <c:pt idx="157">
                  <c:v>43586</c:v>
                </c:pt>
                <c:pt idx="158">
                  <c:v>43617</c:v>
                </c:pt>
                <c:pt idx="159">
                  <c:v>43647</c:v>
                </c:pt>
                <c:pt idx="160">
                  <c:v>43678</c:v>
                </c:pt>
                <c:pt idx="161">
                  <c:v>43709</c:v>
                </c:pt>
                <c:pt idx="162">
                  <c:v>43739</c:v>
                </c:pt>
                <c:pt idx="163">
                  <c:v>43770</c:v>
                </c:pt>
                <c:pt idx="164">
                  <c:v>43800</c:v>
                </c:pt>
                <c:pt idx="165">
                  <c:v>43831</c:v>
                </c:pt>
                <c:pt idx="166">
                  <c:v>43862</c:v>
                </c:pt>
                <c:pt idx="167">
                  <c:v>43891</c:v>
                </c:pt>
              </c:numCache>
            </c:numRef>
          </c:cat>
          <c:val>
            <c:numRef>
              <c:f>Graphs!$F$2:$F$169</c:f>
              <c:numCache>
                <c:formatCode>General</c:formatCode>
                <c:ptCount val="168"/>
                <c:pt idx="0">
                  <c:v>252.5008696129949</c:v>
                </c:pt>
                <c:pt idx="1">
                  <c:v>290.50824550062862</c:v>
                </c:pt>
                <c:pt idx="2">
                  <c:v>351.36536445719707</c:v>
                </c:pt>
                <c:pt idx="3">
                  <c:v>465.54055956644271</c:v>
                </c:pt>
                <c:pt idx="4">
                  <c:v>290.05015326086948</c:v>
                </c:pt>
                <c:pt idx="5">
                  <c:v>312.99340129486035</c:v>
                </c:pt>
                <c:pt idx="6">
                  <c:v>358.84839971112365</c:v>
                </c:pt>
                <c:pt idx="7">
                  <c:v>206.17630867851912</c:v>
                </c:pt>
                <c:pt idx="8">
                  <c:v>290.21539119793971</c:v>
                </c:pt>
                <c:pt idx="9">
                  <c:v>359.00174512772469</c:v>
                </c:pt>
                <c:pt idx="10">
                  <c:v>221.54327217961139</c:v>
                </c:pt>
                <c:pt idx="11">
                  <c:v>450.79018821078682</c:v>
                </c:pt>
                <c:pt idx="12">
                  <c:v>305.66401843188265</c:v>
                </c:pt>
                <c:pt idx="13">
                  <c:v>351.56372009866641</c:v>
                </c:pt>
                <c:pt idx="14">
                  <c:v>351.61383328323086</c:v>
                </c:pt>
                <c:pt idx="15">
                  <c:v>458.69212272582655</c:v>
                </c:pt>
                <c:pt idx="16">
                  <c:v>336.39098855180242</c:v>
                </c:pt>
                <c:pt idx="17">
                  <c:v>351.69901705363264</c:v>
                </c:pt>
                <c:pt idx="18">
                  <c:v>359.36255973253986</c:v>
                </c:pt>
                <c:pt idx="19">
                  <c:v>397.61243864612595</c:v>
                </c:pt>
                <c:pt idx="20">
                  <c:v>282.93064653115005</c:v>
                </c:pt>
                <c:pt idx="21">
                  <c:v>344.12199517180863</c:v>
                </c:pt>
                <c:pt idx="22">
                  <c:v>336.49161497446426</c:v>
                </c:pt>
                <c:pt idx="23">
                  <c:v>367.10006388889707</c:v>
                </c:pt>
                <c:pt idx="24">
                  <c:v>405.35986445973049</c:v>
                </c:pt>
                <c:pt idx="25">
                  <c:v>283.00118587044994</c:v>
                </c:pt>
                <c:pt idx="26">
                  <c:v>313.611546387347</c:v>
                </c:pt>
                <c:pt idx="27">
                  <c:v>367.17329053708323</c:v>
                </c:pt>
                <c:pt idx="28">
                  <c:v>390.15902970792951</c:v>
                </c:pt>
                <c:pt idx="29">
                  <c:v>351.94189192494929</c:v>
                </c:pt>
                <c:pt idx="30">
                  <c:v>397.88551273475275</c:v>
                </c:pt>
                <c:pt idx="31">
                  <c:v>367.31416310784988</c:v>
                </c:pt>
                <c:pt idx="32">
                  <c:v>336.73694829705897</c:v>
                </c:pt>
                <c:pt idx="33">
                  <c:v>420.96156659472382</c:v>
                </c:pt>
                <c:pt idx="34">
                  <c:v>344.45614546377919</c:v>
                </c:pt>
                <c:pt idx="35">
                  <c:v>390.42109030518617</c:v>
                </c:pt>
                <c:pt idx="36">
                  <c:v>367.49040590500493</c:v>
                </c:pt>
                <c:pt idx="37">
                  <c:v>566.60208192432333</c:v>
                </c:pt>
                <c:pt idx="38">
                  <c:v>398.19102958781218</c:v>
                </c:pt>
                <c:pt idx="39">
                  <c:v>505.44482008354674</c:v>
                </c:pt>
                <c:pt idx="40">
                  <c:v>405.88239431775571</c:v>
                </c:pt>
                <c:pt idx="41">
                  <c:v>513.09014859894796</c:v>
                </c:pt>
                <c:pt idx="42">
                  <c:v>421.18810018179505</c:v>
                </c:pt>
                <c:pt idx="43">
                  <c:v>505.41935391713031</c:v>
                </c:pt>
                <c:pt idx="44">
                  <c:v>505.41298777648342</c:v>
                </c:pt>
                <c:pt idx="45">
                  <c:v>566.66803049877774</c:v>
                </c:pt>
                <c:pt idx="46">
                  <c:v>405.85172070823745</c:v>
                </c:pt>
                <c:pt idx="47">
                  <c:v>543.68130624982928</c:v>
                </c:pt>
                <c:pt idx="48">
                  <c:v>558.98923199516048</c:v>
                </c:pt>
                <c:pt idx="49">
                  <c:v>528.35303036408334</c:v>
                </c:pt>
                <c:pt idx="50">
                  <c:v>551.31795741837288</c:v>
                </c:pt>
                <c:pt idx="51">
                  <c:v>589.59650082899566</c:v>
                </c:pt>
                <c:pt idx="52">
                  <c:v>536.04171346228395</c:v>
                </c:pt>
                <c:pt idx="53">
                  <c:v>459.50281329461444</c:v>
                </c:pt>
                <c:pt idx="54">
                  <c:v>520.81348150787846</c:v>
                </c:pt>
                <c:pt idx="55">
                  <c:v>520.857115258573</c:v>
                </c:pt>
                <c:pt idx="56">
                  <c:v>459.6183144010156</c:v>
                </c:pt>
                <c:pt idx="57">
                  <c:v>413.69114490679891</c:v>
                </c:pt>
                <c:pt idx="58">
                  <c:v>436.71058003221583</c:v>
                </c:pt>
                <c:pt idx="59">
                  <c:v>444.40941113407371</c:v>
                </c:pt>
                <c:pt idx="60">
                  <c:v>467.43527966692835</c:v>
                </c:pt>
                <c:pt idx="61">
                  <c:v>429.15688231017913</c:v>
                </c:pt>
                <c:pt idx="62">
                  <c:v>620.79681271001164</c:v>
                </c:pt>
                <c:pt idx="63">
                  <c:v>574.8600536541262</c:v>
                </c:pt>
                <c:pt idx="64">
                  <c:v>497.82648744960613</c:v>
                </c:pt>
                <c:pt idx="65">
                  <c:v>566.31804349844356</c:v>
                </c:pt>
                <c:pt idx="66">
                  <c:v>466.46902412349726</c:v>
                </c:pt>
                <c:pt idx="67">
                  <c:v>687.70160660299189</c:v>
                </c:pt>
                <c:pt idx="68">
                  <c:v>511.56066810661611</c:v>
                </c:pt>
                <c:pt idx="69">
                  <c:v>465.3902177232996</c:v>
                </c:pt>
                <c:pt idx="70">
                  <c:v>625.12461206381806</c:v>
                </c:pt>
                <c:pt idx="71">
                  <c:v>556.08501705021411</c:v>
                </c:pt>
                <c:pt idx="72">
                  <c:v>411.03418107842987</c:v>
                </c:pt>
                <c:pt idx="73">
                  <c:v>578.04796074122157</c:v>
                </c:pt>
                <c:pt idx="74">
                  <c:v>524.40367985599016</c:v>
                </c:pt>
                <c:pt idx="75">
                  <c:v>508.81283421959574</c:v>
                </c:pt>
                <c:pt idx="76">
                  <c:v>637.99961333881538</c:v>
                </c:pt>
                <c:pt idx="77">
                  <c:v>524.14096349773558</c:v>
                </c:pt>
                <c:pt idx="78">
                  <c:v>493.82180076866422</c:v>
                </c:pt>
                <c:pt idx="79">
                  <c:v>516.68245308853852</c:v>
                </c:pt>
                <c:pt idx="80">
                  <c:v>585.14490916854106</c:v>
                </c:pt>
                <c:pt idx="81">
                  <c:v>585.22294373573595</c:v>
                </c:pt>
                <c:pt idx="82">
                  <c:v>539.69312905777122</c:v>
                </c:pt>
                <c:pt idx="83">
                  <c:v>501.75349313711769</c:v>
                </c:pt>
                <c:pt idx="84">
                  <c:v>646.28389157397044</c:v>
                </c:pt>
                <c:pt idx="85">
                  <c:v>623.55706234249908</c:v>
                </c:pt>
                <c:pt idx="86">
                  <c:v>684.48322867708998</c:v>
                </c:pt>
                <c:pt idx="87">
                  <c:v>715.00012110885029</c:v>
                </c:pt>
                <c:pt idx="88">
                  <c:v>699.95032522283327</c:v>
                </c:pt>
                <c:pt idx="89">
                  <c:v>654.45380594136918</c:v>
                </c:pt>
                <c:pt idx="90">
                  <c:v>586.1009823167019</c:v>
                </c:pt>
                <c:pt idx="91">
                  <c:v>723.28012390542756</c:v>
                </c:pt>
                <c:pt idx="92">
                  <c:v>586.37422958966408</c:v>
                </c:pt>
                <c:pt idx="93">
                  <c:v>563.65987286482459</c:v>
                </c:pt>
                <c:pt idx="94">
                  <c:v>617.12293860861359</c:v>
                </c:pt>
                <c:pt idx="95">
                  <c:v>655.36978903008378</c:v>
                </c:pt>
                <c:pt idx="96">
                  <c:v>472.58613415764722</c:v>
                </c:pt>
                <c:pt idx="97">
                  <c:v>655.67568678040107</c:v>
                </c:pt>
                <c:pt idx="98">
                  <c:v>579.5695866297591</c:v>
                </c:pt>
                <c:pt idx="99">
                  <c:v>564.44951623861834</c:v>
                </c:pt>
                <c:pt idx="100">
                  <c:v>495.97107013058178</c:v>
                </c:pt>
                <c:pt idx="101">
                  <c:v>557.2056389197428</c:v>
                </c:pt>
                <c:pt idx="102">
                  <c:v>633.75360256805868</c:v>
                </c:pt>
                <c:pt idx="103">
                  <c:v>641.61039630615153</c:v>
                </c:pt>
                <c:pt idx="104">
                  <c:v>641.83175710836542</c:v>
                </c:pt>
                <c:pt idx="105">
                  <c:v>626.76628806999361</c:v>
                </c:pt>
                <c:pt idx="106">
                  <c:v>604.04428622965918</c:v>
                </c:pt>
                <c:pt idx="107">
                  <c:v>657.79429875128221</c:v>
                </c:pt>
                <c:pt idx="108">
                  <c:v>589.15883569909079</c:v>
                </c:pt>
                <c:pt idx="109">
                  <c:v>612.32462496843357</c:v>
                </c:pt>
                <c:pt idx="110">
                  <c:v>658.47654417291642</c:v>
                </c:pt>
                <c:pt idx="111">
                  <c:v>727.63844211377921</c:v>
                </c:pt>
                <c:pt idx="112">
                  <c:v>536.09498214648693</c:v>
                </c:pt>
                <c:pt idx="113">
                  <c:v>574.32357429740432</c:v>
                </c:pt>
                <c:pt idx="114">
                  <c:v>612.54366073869971</c:v>
                </c:pt>
                <c:pt idx="115">
                  <c:v>627.78741215671243</c:v>
                </c:pt>
                <c:pt idx="116">
                  <c:v>673.64814278159986</c:v>
                </c:pt>
                <c:pt idx="117">
                  <c:v>750.11563778845027</c:v>
                </c:pt>
                <c:pt idx="118">
                  <c:v>566.35086455618364</c:v>
                </c:pt>
                <c:pt idx="119">
                  <c:v>528.0251986236168</c:v>
                </c:pt>
                <c:pt idx="120">
                  <c:v>619.78675623751417</c:v>
                </c:pt>
                <c:pt idx="121">
                  <c:v>581.46367096682002</c:v>
                </c:pt>
                <c:pt idx="122">
                  <c:v>665.54890312382759</c:v>
                </c:pt>
                <c:pt idx="123">
                  <c:v>665.47493619070633</c:v>
                </c:pt>
                <c:pt idx="124">
                  <c:v>459.23843724299468</c:v>
                </c:pt>
                <c:pt idx="125">
                  <c:v>650.99943065198147</c:v>
                </c:pt>
                <c:pt idx="126">
                  <c:v>597.76593557221963</c:v>
                </c:pt>
                <c:pt idx="127">
                  <c:v>605.81315853500723</c:v>
                </c:pt>
                <c:pt idx="128">
                  <c:v>675.25764268317891</c:v>
                </c:pt>
                <c:pt idx="129">
                  <c:v>552.83398413807367</c:v>
                </c:pt>
                <c:pt idx="130">
                  <c:v>606.9667513879524</c:v>
                </c:pt>
                <c:pt idx="131">
                  <c:v>553.53623628793946</c:v>
                </c:pt>
                <c:pt idx="132">
                  <c:v>446.18758119558618</c:v>
                </c:pt>
                <c:pt idx="133">
                  <c:v>515.7513668427971</c:v>
                </c:pt>
                <c:pt idx="134">
                  <c:v>531.48492584923304</c:v>
                </c:pt>
                <c:pt idx="135">
                  <c:v>524.11576729495471</c:v>
                </c:pt>
                <c:pt idx="136">
                  <c:v>547.47089604620157</c:v>
                </c:pt>
                <c:pt idx="137">
                  <c:v>516.84693439183582</c:v>
                </c:pt>
                <c:pt idx="138">
                  <c:v>463.04470750364123</c:v>
                </c:pt>
                <c:pt idx="139">
                  <c:v>378.31395808433899</c:v>
                </c:pt>
                <c:pt idx="140">
                  <c:v>378.47487515087084</c:v>
                </c:pt>
                <c:pt idx="141">
                  <c:v>409.54498461120033</c:v>
                </c:pt>
                <c:pt idx="142">
                  <c:v>324.68324598271732</c:v>
                </c:pt>
                <c:pt idx="143">
                  <c:v>456.29690768946807</c:v>
                </c:pt>
                <c:pt idx="144">
                  <c:v>410.06847914582346</c:v>
                </c:pt>
                <c:pt idx="145">
                  <c:v>325.09844422096035</c:v>
                </c:pt>
                <c:pt idx="146">
                  <c:v>425.90569962122999</c:v>
                </c:pt>
                <c:pt idx="147">
                  <c:v>433.83444465449259</c:v>
                </c:pt>
                <c:pt idx="148">
                  <c:v>565.55096953545421</c:v>
                </c:pt>
                <c:pt idx="149">
                  <c:v>464.85020817967933</c:v>
                </c:pt>
                <c:pt idx="150">
                  <c:v>495.85493745210272</c:v>
                </c:pt>
                <c:pt idx="151">
                  <c:v>472.62576370125038</c:v>
                </c:pt>
                <c:pt idx="152">
                  <c:v>526.87714403888606</c:v>
                </c:pt>
                <c:pt idx="153">
                  <c:v>581.13174477484097</c:v>
                </c:pt>
                <c:pt idx="154">
                  <c:v>410.67862205342874</c:v>
                </c:pt>
                <c:pt idx="155">
                  <c:v>526.92406049478745</c:v>
                </c:pt>
                <c:pt idx="156">
                  <c:v>379.70654937267875</c:v>
                </c:pt>
                <c:pt idx="157">
                  <c:v>488.20862639379965</c:v>
                </c:pt>
                <c:pt idx="158">
                  <c:v>348.73079910015815</c:v>
                </c:pt>
                <c:pt idx="159">
                  <c:v>433.98898839739724</c:v>
                </c:pt>
                <c:pt idx="160">
                  <c:v>372.00160458242101</c:v>
                </c:pt>
                <c:pt idx="161">
                  <c:v>418.51422937917016</c:v>
                </c:pt>
                <c:pt idx="162">
                  <c:v>341.02171835178251</c:v>
                </c:pt>
                <c:pt idx="163">
                  <c:v>333.28111929131086</c:v>
                </c:pt>
                <c:pt idx="164">
                  <c:v>472.80818324312048</c:v>
                </c:pt>
                <c:pt idx="165">
                  <c:v>333.30091013084302</c:v>
                </c:pt>
                <c:pt idx="166">
                  <c:v>348.813634638189</c:v>
                </c:pt>
                <c:pt idx="167">
                  <c:v>364.32728037405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A5-4675-94DB-8BF161834D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60412704"/>
        <c:axId val="1260413120"/>
      </c:lineChart>
      <c:dateAx>
        <c:axId val="1260412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ont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[$-409]mmmm\ d\,\ yyyy;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0413120"/>
        <c:crosses val="autoZero"/>
        <c:auto val="1"/>
        <c:lblOffset val="100"/>
        <c:baseTimeUnit val="months"/>
      </c:dateAx>
      <c:valAx>
        <c:axId val="1260413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0412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29372-280B-B438-ED48-BCF1774209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76D1D0-7363-A95F-7AB4-0E9A27CD49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5FC581-BBF6-120E-DDDD-75EE863E3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3EB3CA-C332-8C36-85E1-E18A80F40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3CDB3-ECB4-ECE3-9E3A-97C9FA124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463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AE263-84EC-53D5-D96E-D75F7F506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1CDA9F-273D-72FC-5ECA-2883F7DD5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D5AF4A-7861-44D7-7247-018DA9E62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526807-D5E5-2503-5711-004E3A3BE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508DC0-56C0-EC99-247D-435240E34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504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2AD16F-94EE-E4C9-E1F8-24E2DA0027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C3F6DD-ED76-0E6D-BBA8-2AC1CED182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97C900-6C09-2CDD-A877-DA7189820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BEF963-BDCF-67CB-B054-61F711322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0AF0DA-D83A-90E6-1F25-78CB59949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301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24067-D3E9-31A0-942D-27EEBED75C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E0CB66-44C4-1A0F-52D6-5CC487608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D35A3-514D-7299-F6AD-DAD9AD63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CA090-6E79-AF92-3C0C-919CF37DE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F4E2EA-3EBD-3CFF-4606-A813DA12D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867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275AF-5A1D-B88A-0539-BFA22E3769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6BF0F8-EA59-2199-AFB3-7E3A9B020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FFFD0A-4CD0-17FB-6200-47AFA33C6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6C5E32-1146-D6ED-5AFE-3860F5988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63FB61-531B-9C7F-2DB7-E84F34121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441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9CA3A-2D69-8E03-6EE5-1045B5B17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F809B-A687-6DEF-8C67-73C80EFC38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16A5F6-17D5-D1A9-9DD8-21DCB1642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53DE13-8FF1-63AF-BBC3-9C0BFC3E3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A7D41D-B9D4-A942-9CD9-F594BAB1B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7013AF-D670-A16B-28D7-37E62E1C3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693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0E52E-C0A1-7C8E-89E0-511102133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474B91-D09F-E0FF-0A6A-B81C6B069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812E66-1365-3424-3600-344BA32004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422054-9A07-DC5E-4BF7-E891D9DD0C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22998A-689D-89B4-ADF3-B3EB9B2D08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47CFE30-ABA7-B8E7-925C-EC0697170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6E3FFD-6E99-4229-CB43-77A83025C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1E3F32-9240-6D11-DA77-302A53F43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314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793DC-7F85-FF8E-11A5-9572B7B556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71F954-24C9-58FB-FB61-6178B91E4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B387DA-F862-682B-E672-6D3C9116A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2C8F09-D9B7-256D-54A1-923DF4833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899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B54B27-CC0A-5D4F-DA3D-3B4C3EC3E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2B3E5B-A769-8823-07DB-A45DD26CF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9FD923-3A32-A4B5-1B0A-527E698BF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671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C4008-6EB0-E046-54EC-0E8EC15BC3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35B863-23A8-FFA3-18DE-C9E7DEAEC2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4AE80E-AA43-A4EB-83F2-0B9A3C2EDC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77657D-19F8-B9B5-A676-BE82C6A95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89986E-7968-B92C-F598-367CC9A79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FA4228-D286-DCCE-C858-82BA93D66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842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D388F-2D85-610A-A02C-135BB5A11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DDE772-AA9D-76BF-BAC9-82A0A9CFC1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38143A-FAF3-A335-6F5D-46799822D9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090D6B-BDA1-FB70-BD88-EC0C29536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9DD967-53CD-5885-84C0-C1E36AB71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60F482-4C38-1DAF-B714-D55CB825D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431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5F00C2-A3B9-7E4B-BE21-8DCF9FCF89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66862E-D361-41D9-8260-FD4E75AFD9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7C060-611E-BBD8-B4E1-AFF032B1EE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04AF6-ECD4-4B11-B838-D2C1D0ECCC8B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34F546-1BD8-A120-0DFF-0199273A20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F89C43-068C-505C-726D-22496E9BF6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E464D-2D18-4052-A5A3-AA2786F80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255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F8CC188-3B24-424E-B789-52E1F162C2A5}"/>
              </a:ext>
            </a:extLst>
          </p:cNvPr>
          <p:cNvGraphicFramePr>
            <a:graphicFrameLocks/>
          </p:cNvGraphicFramePr>
          <p:nvPr/>
        </p:nvGraphicFramePr>
        <p:xfrm>
          <a:off x="1773848" y="1090473"/>
          <a:ext cx="8581114" cy="4857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AB3ED886-E181-47FD-B38E-39295B8AC411}"/>
              </a:ext>
            </a:extLst>
          </p:cNvPr>
          <p:cNvCxnSpPr>
            <a:cxnSpLocks/>
          </p:cNvCxnSpPr>
          <p:nvPr/>
        </p:nvCxnSpPr>
        <p:spPr>
          <a:xfrm>
            <a:off x="7123670" y="1594022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E1E12302-79F6-4B51-AE91-2B7016C451C1}"/>
              </a:ext>
            </a:extLst>
          </p:cNvPr>
          <p:cNvCxnSpPr>
            <a:cxnSpLocks/>
          </p:cNvCxnSpPr>
          <p:nvPr/>
        </p:nvCxnSpPr>
        <p:spPr>
          <a:xfrm>
            <a:off x="8368612" y="1594022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E51243D0-21EB-E333-B0D2-7766DFD64F15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6 Figure</a:t>
            </a:r>
          </a:p>
        </p:txBody>
      </p:sp>
    </p:spTree>
    <p:extLst>
      <p:ext uri="{BB962C8B-B14F-4D97-AF65-F5344CB8AC3E}">
        <p14:creationId xmlns:p14="http://schemas.microsoft.com/office/powerpoint/2010/main" val="1276175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7:47Z</dcterms:created>
  <dcterms:modified xsi:type="dcterms:W3CDTF">2023-07-26T15:47:54Z</dcterms:modified>
</cp:coreProperties>
</file>